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330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8650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8637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6019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8487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351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296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815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731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4951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91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87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734A1-549B-46EE-AAE4-7289B03A47E7}" type="datetimeFigureOut">
              <a:rPr lang="en-US" smtClean="0"/>
              <a:t>4/22/2016</a:t>
            </a:fld>
            <a:endParaRPr 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02E20-B9F7-42EA-BB8A-2A52F250012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71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2129583"/>
              </p:ext>
            </p:extLst>
          </p:nvPr>
        </p:nvGraphicFramePr>
        <p:xfrm>
          <a:off x="1187625" y="1844824"/>
          <a:ext cx="6264696" cy="2844165"/>
        </p:xfrm>
        <a:graphic>
          <a:graphicData uri="http://schemas.openxmlformats.org/drawingml/2006/table">
            <a:tbl>
              <a:tblPr/>
              <a:tblGrid>
                <a:gridCol w="2240744"/>
                <a:gridCol w="1255286"/>
                <a:gridCol w="954174"/>
                <a:gridCol w="907246"/>
                <a:gridCol w="907246"/>
              </a:tblGrid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ll type 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tige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an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o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talog No.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rdiomyocyt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pha-actinin</a:t>
                      </a: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sarcomeric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gma-Aldric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A5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78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ndothelial cel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3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ecton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Dickins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q13.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337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S-lect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ector laborator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10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utrophil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P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bcam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b212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crophag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c2</a:t>
                      </a: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Galectin-3, H-160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nta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ruz Biotechnology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-201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6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rote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A-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ibroblas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imenti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nta</a:t>
                      </a:r>
                      <a:r>
                        <a:rPr lang="en-US" sz="11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Cruz Biotechnolog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-55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100A4 (Fsp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AKO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51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yofibroblast /Smooth muscle cel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α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m-acti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igma-Aldrich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A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254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187625" y="1124744"/>
            <a:ext cx="647805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EV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bodies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sed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r Fstl1 co-localization in different cell types   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8807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80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Presentation</vt:lpstr>
    </vt:vector>
  </TitlesOfParts>
  <Company>b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56</cp:revision>
  <cp:lastPrinted>2015-12-11T18:55:13Z</cp:lastPrinted>
  <dcterms:created xsi:type="dcterms:W3CDTF">2015-07-06T18:02:00Z</dcterms:created>
  <dcterms:modified xsi:type="dcterms:W3CDTF">2016-04-22T13:32:10Z</dcterms:modified>
</cp:coreProperties>
</file>